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56" r:id="rId4"/>
    <p:sldId id="259" r:id="rId5"/>
    <p:sldId id="263" r:id="rId6"/>
    <p:sldId id="262" r:id="rId7"/>
    <p:sldId id="26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Hidden" id="{5AC7FA4B-68DA-49E1-8D01-1A8599CC0602}">
          <p14:sldIdLst>
            <p14:sldId id="257"/>
            <p14:sldId id="258"/>
          </p14:sldIdLst>
        </p14:section>
        <p14:section name="Figures" id="{5E637066-4B4B-4FC5-A509-1797C1E8025D}">
          <p14:sldIdLst>
            <p14:sldId id="256"/>
            <p14:sldId id="259"/>
            <p14:sldId id="263"/>
          </p14:sldIdLst>
        </p14:section>
        <p14:section name="Tables" id="{F7782BEE-2EE6-49C8-9FE5-658B6F859985}">
          <p14:sldIdLst>
            <p14:sldId id="262"/>
            <p14:sldId id="26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776" y="11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752B-CB17-4814-B2C0-DF3F484BEB7F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CDE51-60D2-4EAE-BFC6-9CD8C57A07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780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45c26e9ee6_0_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45c26e9ee6_0_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45c26e9ee6_0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45c26e9ee6_0_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AMRI_IP_vs_IXI_noisy_local_SNR.py</a:t>
            </a:r>
            <a:br>
              <a:rPr lang="en"/>
            </a:br>
            <a:r>
              <a:rPr lang="en"/>
              <a:t>Pooled means failed – brain masking is not perfect and some slices had 0s within the cropped region, this skewed the plot</a:t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87469-C8D6-7D71-B5D1-0E35E4E186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A0E880-6F6E-5A90-1A9E-5FEDCB1A14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057C91-769E-C07E-ED62-56B2EF658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61192D-ABB4-963A-EE4B-F991C2330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DEB2B3-5F6E-CC5C-015F-FFF7AA7A3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435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9FD67-A8A3-45DC-7128-7C10E3AD04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0B3A4A-CFEB-9733-E273-4852456B1D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96B4FB-AEB7-91D8-D727-50030DAC0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7D632-5511-D352-7508-2C96A613B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8A2DBC-EBBF-2997-0249-5C67FA95B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637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A779BB-0552-3664-D5CF-67E9ECFE06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BEBC45-8C7B-A2E3-3310-D0B68DBAC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9E0A8-DBA0-D95D-D28D-03F25DAEC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F7684-753C-7C58-3479-99563ECB7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546773-54AF-47C9-666C-C7CAF7794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32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6A677-B152-195B-FBE5-BC84AFEC9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B93FD4-DEF7-A842-94F0-832100F635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4097E5-E8BA-6CD3-A4EA-F17159F44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F62DF-93C6-1C20-D14A-AA7CF384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3CFB50-A28D-DEE1-49FD-E61D70B66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707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0EB063-B144-3671-EFE3-A64CC2967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29347-D884-E996-82B3-7E1CD287B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726C65-CA21-5F56-76B0-4077DA61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723AA-B120-4251-E380-8E15B9C71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14502-71EE-3404-D7DD-6F839AE7C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3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07485B-C851-B07E-C46C-CC8826154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768D60-F746-0BD4-0891-FA0A0FC07B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A0A4F9-41DD-686F-9F3C-4E46620EA8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BE7A51-115A-4FD5-096E-B28B69C18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4767EC-87F9-0F51-9582-CD0EAE988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D3050E-C2D1-9149-13AA-40568B05B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82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DE942-202D-ABCB-7BFF-2A16E1A7E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6C20C8-B0C2-81FA-F8B6-EF366CC66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C30D53-055E-4EDB-6077-4B8755758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3AB2FB-AC27-9ED5-B79A-867CEF93DD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5FCF4B-B02F-F369-656A-A14CAE33F6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EBA704-0B09-B3B7-6BBC-C5676DECA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D00AC7-6F9F-4B50-C574-BAABDF5C9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A118C3-2550-4DD2-8661-F9C93469B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2148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80EB6-28A5-F3F3-F68B-B4885BBD6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D48112-AD9A-77AE-8235-8C5CD32E2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085B04-2F79-73BC-25EA-B89807D0E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762754-1B5D-050B-D7B2-4E37B3478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633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0C0EED-3F12-ED3A-BE0D-DCE2955D9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82E5EF-0DA3-EBCA-91BE-9A7930E01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0EA2AA-4BDE-D761-39D4-5693B771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79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51AE1F-282B-E746-EFED-2ADEA3CA2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6BC07A-1065-9263-3B97-5962381439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D35213-58C7-F668-E502-3E80DA715F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A097F1-5F9F-DAA9-8A69-6641967C1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9117B-F63F-D386-0E3C-B2A0F7BC9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7D1749-DD5C-3772-3E8B-F965E6ECF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935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8ED83F-74FD-3886-BF31-B2705A9746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2B7DB1-67FF-E76D-1316-17F4861C53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F6470D-FC56-2097-0595-A87DAAA206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662355-5A92-39CC-CEEF-3B39F36F5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65F4B-3FBA-733C-BD79-D57B4EF9B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BBBC00-CF5B-B9E8-DCF4-71FF10E54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75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C92797-3B2C-1005-2134-015556A98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8E1751-FD27-9337-E424-7FFA4400D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A6BB5C-24B2-A4D0-CCF3-175BCCA828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FBCBC-55FC-4DA2-B693-DC1C471E18F0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C9C0DF-5263-8137-D760-27F42C76A9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75EC6-9AE8-A54C-A9A2-3ED5542F7A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6FCD4-7A0A-4C3F-ADF4-E81412B8F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765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ctr" anchorCtr="0">
            <a:normAutofit/>
          </a:bodyPr>
          <a:lstStyle/>
          <a:p>
            <a:fld id="{00000000-1234-1234-1234-123412341234}" type="slidenum">
              <a:rPr lang="en"/>
              <a:pPr/>
              <a:t>1</a:t>
            </a:fld>
            <a:endParaRPr/>
          </a:p>
        </p:txBody>
      </p:sp>
      <p:pic>
        <p:nvPicPr>
          <p:cNvPr id="55" name="Google Shape;55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3201" y="203201"/>
            <a:ext cx="10683473" cy="58112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ctr" anchorCtr="0">
            <a:normAutofit/>
          </a:bodyPr>
          <a:lstStyle/>
          <a:p>
            <a:fld id="{00000000-1234-1234-1234-123412341234}" type="slidenum">
              <a:rPr lang="en"/>
              <a:pPr/>
              <a:t>2</a:t>
            </a:fld>
            <a:endParaRPr/>
          </a:p>
        </p:txBody>
      </p:sp>
      <p:pic>
        <p:nvPicPr>
          <p:cNvPr id="61" name="Google Shape;61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03201" y="203201"/>
            <a:ext cx="10683473" cy="58112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1FC50405-C6EF-1FC7-60C6-880A0293CC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3856"/>
            <a:ext cx="12192000" cy="61102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3CA373A-28C0-51FC-02D0-242C12A015AB}"/>
              </a:ext>
            </a:extLst>
          </p:cNvPr>
          <p:cNvSpPr txBox="1"/>
          <p:nvPr/>
        </p:nvSpPr>
        <p:spPr>
          <a:xfrm>
            <a:off x="0" y="6611779"/>
            <a:ext cx="12192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1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Search criteria to filter the ADNI-3 dataset. From the results of this search, 89 Axial T</a:t>
            </a:r>
            <a:r>
              <a:rPr lang="en-US" sz="1000" i="1" baseline="-25000" dirty="0">
                <a:latin typeface="Roboto" panose="02000000000000000000" pitchFamily="2" charset="0"/>
                <a:ea typeface="Roboto" panose="02000000000000000000" pitchFamily="2" charset="0"/>
              </a:rPr>
              <a:t>2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* samples from different subjects were randomly chosen.</a:t>
            </a:r>
          </a:p>
        </p:txBody>
      </p:sp>
    </p:spTree>
    <p:extLst>
      <p:ext uri="{BB962C8B-B14F-4D97-AF65-F5344CB8AC3E}">
        <p14:creationId xmlns:p14="http://schemas.microsoft.com/office/powerpoint/2010/main" val="5462763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>
            <a:spLocks noGrp="1"/>
          </p:cNvSpPr>
          <p:nvPr>
            <p:ph type="sldNum" idx="12"/>
          </p:nvPr>
        </p:nvSpPr>
        <p:spPr>
          <a:xfrm>
            <a:off x="11296611" y="6217623"/>
            <a:ext cx="731600" cy="524800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ctr" anchorCtr="0">
            <a:normAutofit/>
          </a:bodyPr>
          <a:lstStyle/>
          <a:p>
            <a:fld id="{00000000-1234-1234-1234-123412341234}" type="slidenum">
              <a:rPr lang="en"/>
              <a:pPr/>
              <a:t>4</a:t>
            </a:fld>
            <a:endParaRPr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F5EA359-C795-0B56-22C5-54281669E82E}"/>
              </a:ext>
            </a:extLst>
          </p:cNvPr>
          <p:cNvGrpSpPr/>
          <p:nvPr/>
        </p:nvGrpSpPr>
        <p:grpSpPr>
          <a:xfrm>
            <a:off x="2730018" y="0"/>
            <a:ext cx="6731964" cy="6393329"/>
            <a:chOff x="969433" y="23185"/>
            <a:chExt cx="6731964" cy="6393329"/>
          </a:xfrm>
        </p:grpSpPr>
        <p:pic>
          <p:nvPicPr>
            <p:cNvPr id="70" name="Google Shape;70;p15"/>
            <p:cNvPicPr preferRelativeResize="0"/>
            <p:nvPr/>
          </p:nvPicPr>
          <p:blipFill rotWithShape="1">
            <a:blip r:embed="rId3">
              <a:alphaModFix/>
            </a:blip>
            <a:srcRect l="11159" t="13527" r="7973" b="15013"/>
            <a:stretch/>
          </p:blipFill>
          <p:spPr>
            <a:xfrm>
              <a:off x="1447433" y="23185"/>
              <a:ext cx="6253964" cy="300606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1" name="Google Shape;71;p15"/>
            <p:cNvPicPr preferRelativeResize="0"/>
            <p:nvPr/>
          </p:nvPicPr>
          <p:blipFill rotWithShape="1">
            <a:blip r:embed="rId4">
              <a:alphaModFix/>
            </a:blip>
            <a:srcRect l="9380" t="11001" r="9258" b="8696"/>
            <a:stretch/>
          </p:blipFill>
          <p:spPr>
            <a:xfrm>
              <a:off x="1447433" y="3059067"/>
              <a:ext cx="6253964" cy="33574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3" name="Google Shape;73;p15"/>
            <p:cNvSpPr txBox="1"/>
            <p:nvPr/>
          </p:nvSpPr>
          <p:spPr>
            <a:xfrm>
              <a:off x="969433" y="32750"/>
              <a:ext cx="478000" cy="49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/>
              <a:r>
                <a:rPr lang="en" sz="1600" b="1" dirty="0">
                  <a:latin typeface="Roboto"/>
                  <a:ea typeface="Roboto"/>
                  <a:cs typeface="Roboto"/>
                  <a:sym typeface="Roboto"/>
                </a:rPr>
                <a:t>a)</a:t>
              </a:r>
              <a:endParaRPr sz="1600" b="1" dirty="0">
                <a:latin typeface="Roboto"/>
                <a:ea typeface="Roboto"/>
                <a:cs typeface="Roboto"/>
                <a:sym typeface="Roboto"/>
              </a:endParaRPr>
            </a:p>
          </p:txBody>
        </p:sp>
        <p:sp>
          <p:nvSpPr>
            <p:cNvPr id="74" name="Google Shape;74;p15"/>
            <p:cNvSpPr txBox="1"/>
            <p:nvPr/>
          </p:nvSpPr>
          <p:spPr>
            <a:xfrm>
              <a:off x="969433" y="3059067"/>
              <a:ext cx="478000" cy="492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1900" tIns="121900" rIns="121900" bIns="121900" anchor="ctr" anchorCtr="0">
              <a:noAutofit/>
            </a:bodyPr>
            <a:lstStyle/>
            <a:p>
              <a:pPr algn="ctr"/>
              <a:r>
                <a:rPr lang="en" sz="1600" b="1" dirty="0">
                  <a:latin typeface="Roboto"/>
                  <a:ea typeface="Roboto"/>
                  <a:cs typeface="Roboto"/>
                  <a:sym typeface="Roboto"/>
                </a:rPr>
                <a:t>b)</a:t>
              </a:r>
              <a:endParaRPr sz="1600" b="1" dirty="0">
                <a:latin typeface="Roboto"/>
                <a:ea typeface="Roboto"/>
                <a:cs typeface="Roboto"/>
                <a:sym typeface="Roboto"/>
              </a:endParaRPr>
            </a:p>
          </p:txBody>
        </p:sp>
      </p:grpSp>
      <p:sp>
        <p:nvSpPr>
          <p:cNvPr id="72" name="Google Shape;72;p15"/>
          <p:cNvSpPr txBox="1"/>
          <p:nvPr/>
        </p:nvSpPr>
        <p:spPr>
          <a:xfrm>
            <a:off x="0" y="6304043"/>
            <a:ext cx="12192000" cy="5539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spAutoFit/>
          </a:bodyPr>
          <a:lstStyle/>
          <a:p>
            <a:pPr algn="just"/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2: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Iterative local SNR-guided approach to determine noise scaling factor for forward simulation of native noise corrupted data. </a:t>
            </a:r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(a)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Representative </a:t>
            </a:r>
            <a:r>
              <a:rPr lang="en" sz="1000" i="1" dirty="0">
                <a:solidFill>
                  <a:schemeClr val="dk1"/>
                </a:solidFill>
                <a:latin typeface="Roboto" panose="02000000000000000000" pitchFamily="2" charset="0"/>
                <a:ea typeface="Roboto" panose="02000000000000000000" pitchFamily="2" charset="0"/>
              </a:rPr>
              <a:t>center slices of 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brain-masked local SNR map of Fastest (left) and IXI (right). Black boxes indicate regions of interest (ROIs). </a:t>
            </a:r>
            <a:r>
              <a:rPr lang="en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(b)</a:t>
            </a:r>
            <a:r>
              <a:rPr lang="en" sz="1000" i="1" dirty="0">
                <a:latin typeface="Roboto" panose="02000000000000000000" pitchFamily="2" charset="0"/>
                <a:ea typeface="Roboto" panose="02000000000000000000" pitchFamily="2" charset="0"/>
              </a:rPr>
              <a:t> Minimum, maximum and mean(dashed) of local SNR values within the ROIs, across central 50% slab of Fastest and IXI.</a:t>
            </a:r>
            <a:endParaRPr sz="1000" i="1" dirty="0">
              <a:latin typeface="Roboto" panose="02000000000000000000" pitchFamily="2" charset="0"/>
              <a:ea typeface="Roboto" panose="02000000000000000000" pitchFamily="2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529D95B-0BC2-30F3-5CDB-1EC4F1CD4E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7418286"/>
              </p:ext>
            </p:extLst>
          </p:nvPr>
        </p:nvGraphicFramePr>
        <p:xfrm>
          <a:off x="1402430" y="14289"/>
          <a:ext cx="9387141" cy="6265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0231456" imgH="6828881" progId="Prism9.Document">
                  <p:embed/>
                </p:oleObj>
              </mc:Choice>
              <mc:Fallback>
                <p:oleObj name="Prism 9" r:id="rId2" imgW="10231456" imgH="682888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02430" y="14289"/>
                        <a:ext cx="9387141" cy="6265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7EC01CE-537F-AB76-884E-EACD805F9DEA}"/>
              </a:ext>
            </a:extLst>
          </p:cNvPr>
          <p:cNvSpPr txBox="1"/>
          <p:nvPr/>
        </p:nvSpPr>
        <p:spPr>
          <a:xfrm>
            <a:off x="0" y="6457890"/>
            <a:ext cx="12192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Figure 3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Training histories of the contrast-specific image baseline denoising models as a function of training epochs. The dashed lines represent the corresponding validation losses. Training durations (</a:t>
            </a:r>
            <a:r>
              <a:rPr lang="en-US" sz="1000" i="1" dirty="0" err="1">
                <a:latin typeface="Roboto" panose="02000000000000000000" pitchFamily="2" charset="0"/>
                <a:ea typeface="Roboto" panose="02000000000000000000" pitchFamily="2" charset="0"/>
              </a:rPr>
              <a:t>hh:mm:ss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) are presented in brackets in the figure legend.</a:t>
            </a:r>
          </a:p>
        </p:txBody>
      </p:sp>
    </p:spTree>
    <p:extLst>
      <p:ext uri="{BB962C8B-B14F-4D97-AF65-F5344CB8AC3E}">
        <p14:creationId xmlns:p14="http://schemas.microsoft.com/office/powerpoint/2010/main" val="4186255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DD43BD2-BD21-35DD-2D20-5028064752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1426245"/>
              </p:ext>
            </p:extLst>
          </p:nvPr>
        </p:nvGraphicFramePr>
        <p:xfrm>
          <a:off x="3948113" y="2034540"/>
          <a:ext cx="4295775" cy="265176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333375">
                  <a:extLst>
                    <a:ext uri="{9D8B030D-6E8A-4147-A177-3AD203B41FA5}">
                      <a16:colId xmlns:a16="http://schemas.microsoft.com/office/drawing/2014/main" val="711942888"/>
                    </a:ext>
                  </a:extLst>
                </a:gridCol>
                <a:gridCol w="2867025">
                  <a:extLst>
                    <a:ext uri="{9D8B030D-6E8A-4147-A177-3AD203B41FA5}">
                      <a16:colId xmlns:a16="http://schemas.microsoft.com/office/drawing/2014/main" val="3028515039"/>
                    </a:ext>
                  </a:extLst>
                </a:gridCol>
                <a:gridCol w="1095375">
                  <a:extLst>
                    <a:ext uri="{9D8B030D-6E8A-4147-A177-3AD203B41FA5}">
                      <a16:colId xmlns:a16="http://schemas.microsoft.com/office/drawing/2014/main" val="349271615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#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Degrees of freedom (DOF)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Weigh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00039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TR – Repetition tim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0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6116739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2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TL – Echo Train Length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9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260534647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Dir – Diffusion direction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8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755155363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T – Slice thickness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7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595265280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ARC – Acceleration facto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6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27925299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6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ASSET – Acceleration facto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0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658473355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7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NEX – Number of averages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0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1955952480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8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457200"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 err="1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SNR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 – Relative SN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0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69999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C8E9493-EE7A-877D-2E3B-D580A1B3877B}"/>
              </a:ext>
            </a:extLst>
          </p:cNvPr>
          <p:cNvSpPr txBox="1"/>
          <p:nvPr/>
        </p:nvSpPr>
        <p:spPr>
          <a:xfrm>
            <a:off x="1060006" y="6611779"/>
            <a:ext cx="100719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Table 1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Degrees of freedom (DOF) and their corresponding weights. DOF contributing more significantly to the image contrast are assigned higher weight values.</a:t>
            </a:r>
          </a:p>
        </p:txBody>
      </p:sp>
    </p:spTree>
    <p:extLst>
      <p:ext uri="{BB962C8B-B14F-4D97-AF65-F5344CB8AC3E}">
        <p14:creationId xmlns:p14="http://schemas.microsoft.com/office/powerpoint/2010/main" val="3991442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0700478-1A26-2C8D-A4F3-CE8F23B620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0059313"/>
              </p:ext>
            </p:extLst>
          </p:nvPr>
        </p:nvGraphicFramePr>
        <p:xfrm>
          <a:off x="2593976" y="2209800"/>
          <a:ext cx="7004049" cy="260604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83034">
                  <a:extLst>
                    <a:ext uri="{9D8B030D-6E8A-4147-A177-3AD203B41FA5}">
                      <a16:colId xmlns:a16="http://schemas.microsoft.com/office/drawing/2014/main" val="3162675754"/>
                    </a:ext>
                  </a:extLst>
                </a:gridCol>
                <a:gridCol w="1324203">
                  <a:extLst>
                    <a:ext uri="{9D8B030D-6E8A-4147-A177-3AD203B41FA5}">
                      <a16:colId xmlns:a16="http://schemas.microsoft.com/office/drawing/2014/main" val="3206331612"/>
                    </a:ext>
                  </a:extLst>
                </a:gridCol>
                <a:gridCol w="1324203">
                  <a:extLst>
                    <a:ext uri="{9D8B030D-6E8A-4147-A177-3AD203B41FA5}">
                      <a16:colId xmlns:a16="http://schemas.microsoft.com/office/drawing/2014/main" val="4185073598"/>
                    </a:ext>
                  </a:extLst>
                </a:gridCol>
                <a:gridCol w="1096060">
                  <a:extLst>
                    <a:ext uri="{9D8B030D-6E8A-4147-A177-3AD203B41FA5}">
                      <a16:colId xmlns:a16="http://schemas.microsoft.com/office/drawing/2014/main" val="1944660635"/>
                    </a:ext>
                  </a:extLst>
                </a:gridCol>
                <a:gridCol w="1562100">
                  <a:extLst>
                    <a:ext uri="{9D8B030D-6E8A-4147-A177-3AD203B41FA5}">
                      <a16:colId xmlns:a16="http://schemas.microsoft.com/office/drawing/2014/main" val="710645720"/>
                    </a:ext>
                  </a:extLst>
                </a:gridCol>
                <a:gridCol w="1314449">
                  <a:extLst>
                    <a:ext uri="{9D8B030D-6E8A-4147-A177-3AD203B41FA5}">
                      <a16:colId xmlns:a16="http://schemas.microsoft.com/office/drawing/2014/main" val="410127295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#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xperiment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Protocol(s) executed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Number of volunteers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Evaluation criteria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Claims</a:t>
                      </a:r>
                      <a:endParaRPr 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45573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Throughput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1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R Valu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Fastest &gt; 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303475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2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Image quality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, EE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S-SSIM, PSNR, median brain-masked local SNR, var-Lap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Fastest ~= EE/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4075806068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3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NR recovery test</a:t>
                      </a:r>
                      <a:endParaRPr lang="en-US" sz="160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r>
                        <a:rPr kumimoji="0" lang="en-US" sz="11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, 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MS-</a:t>
                      </a:r>
                      <a:r>
                        <a:rPr kumimoji="0" lang="en-US" sz="11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SSIM, PSNR</a:t>
                      </a:r>
                      <a:endParaRPr kumimoji="0" lang="en-US" sz="1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Baseline-denoised Fastest ~= G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845138575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4</a:t>
                      </a:r>
                      <a:endParaRPr lang="en-US" sz="1600" b="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epeatability 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GS, Fastest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, MS-SSIM, PSNR</a:t>
                      </a:r>
                      <a:endParaRPr lang="en-US" sz="1600" dirty="0"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CV, ICC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2904327317"/>
                  </a:ext>
                </a:extLst>
              </a:tr>
              <a:tr h="279400"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5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Interpolation test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-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kumimoji="0" lang="en-US" sz="1100" b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RMSE</a:t>
                      </a:r>
                      <a:r>
                        <a:rPr kumimoji="0" lang="en-US" sz="1100" b="0" u="none" strike="noStrike" kern="1200" cap="none" spc="0" normalizeH="0" baseline="-25000" noProof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Roboto" panose="02000000000000000000" pitchFamily="2" charset="0"/>
                          <a:ea typeface="Roboto" panose="02000000000000000000" pitchFamily="2" charset="0"/>
                        </a:rPr>
                        <a:t>vol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tc>
                  <a:txBody>
                    <a:bodyPr/>
                    <a:lstStyle/>
                    <a:p>
                      <a:pPr algn="ctr" rtl="0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Roboto" panose="02000000000000000000" pitchFamily="2" charset="0"/>
                        <a:ea typeface="Roboto" panose="02000000000000000000" pitchFamily="2" charset="0"/>
                        <a:cs typeface="+mn-cs"/>
                      </a:endParaRPr>
                    </a:p>
                  </a:txBody>
                  <a:tcPr marL="63500" marR="63500" marT="63500" marB="63500" anchor="ctr"/>
                </a:tc>
                <a:extLst>
                  <a:ext uri="{0D108BD9-81ED-4DB2-BD59-A6C34878D82A}">
                    <a16:rowId xmlns:a16="http://schemas.microsoft.com/office/drawing/2014/main" val="317893274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4FDE2B4-4B14-5DF0-D755-453892176CF0}"/>
              </a:ext>
            </a:extLst>
          </p:cNvPr>
          <p:cNvSpPr txBox="1"/>
          <p:nvPr/>
        </p:nvSpPr>
        <p:spPr>
          <a:xfrm>
            <a:off x="0" y="6611779"/>
            <a:ext cx="12192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Roboto" panose="02000000000000000000" pitchFamily="2" charset="0"/>
                <a:ea typeface="Roboto" panose="02000000000000000000" pitchFamily="2" charset="0"/>
              </a:rPr>
              <a:t>Supplementary Table 2.</a:t>
            </a:r>
            <a:r>
              <a:rPr lang="en-US" sz="1000" i="1" dirty="0">
                <a:latin typeface="Roboto" panose="02000000000000000000" pitchFamily="2" charset="0"/>
                <a:ea typeface="Roboto" panose="02000000000000000000" pitchFamily="2" charset="0"/>
              </a:rPr>
              <a:t> The five experiments performed in this work and the corresponding protocols involved, number of volunteers imaged, claims/hypotheses investigated and the quantitative evaluation criteria.</a:t>
            </a:r>
          </a:p>
        </p:txBody>
      </p:sp>
    </p:spTree>
    <p:extLst>
      <p:ext uri="{BB962C8B-B14F-4D97-AF65-F5344CB8AC3E}">
        <p14:creationId xmlns:p14="http://schemas.microsoft.com/office/powerpoint/2010/main" val="1111261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3</TotalTime>
  <Words>410</Words>
  <Application>Microsoft Office PowerPoint</Application>
  <PresentationFormat>Widescreen</PresentationFormat>
  <Paragraphs>73</Paragraphs>
  <Slides>7</Slides>
  <Notes>3</Notes>
  <HiddenSlides>2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Roboto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erthi Sravan Ravi</dc:creator>
  <cp:lastModifiedBy>Keerthi Sravan Ravi</cp:lastModifiedBy>
  <cp:revision>64</cp:revision>
  <dcterms:created xsi:type="dcterms:W3CDTF">2022-08-29T14:27:09Z</dcterms:created>
  <dcterms:modified xsi:type="dcterms:W3CDTF">2022-10-03T20:52:07Z</dcterms:modified>
</cp:coreProperties>
</file>